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2C006B9-F445-456D-8646-757FF57AE8D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C67DE9C-A1FC-4722-BD8B-DBBE715BFE2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5EEC70B-00A3-45A7-997F-951FB706150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17BFD75-37F4-4E22-A0A3-E98666F6E51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7E14FE4-E3B5-4DA1-9018-6D81F56388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CF408F7-58EC-4453-B21A-BEC605834E3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B71CC47-366B-4053-B3A2-1314D6DBDAE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1458AB0-2DB2-4371-891A-64A5359278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32DE9B5-3403-4B69-860F-3E42BFC6D1B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CD4C3A6-B4CE-4033-9325-92768C5EBC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1832B8-6196-4B9E-A298-4F880FFE071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5AB5A5B-F867-443A-AD06-91AC41D945F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B833559-4E52-4A05-B31B-050BB06C3460}" type="slidenum">
              <a:rPr b="0" lang="de-DE"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png"/><Relationship Id="rId3" Type="http://schemas.openxmlformats.org/officeDocument/2006/relationships/oleObject" Target="../embeddings/oleObject2.bin"/><Relationship Id="rId4" Type="http://schemas.openxmlformats.org/officeDocument/2006/relationships/image" Target="../media/image2.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Object 4"/>
          <p:cNvGraphicFramePr/>
          <p:nvPr/>
        </p:nvGraphicFramePr>
        <p:xfrm>
          <a:off x="250920" y="189000"/>
          <a:ext cx="3529080" cy="3247920"/>
        </p:xfrm>
        <a:graphic>
          <a:graphicData uri="http://schemas.openxmlformats.org/presentationml/2006/ole">
            <p:oleObj r:id="rId1" spid="">
              <p:embed/>
              <p:pic>
                <p:nvPicPr>
                  <p:cNvPr id="42" name="Object 4" descr=""/>
                  <p:cNvPicPr/>
                  <p:nvPr/>
                </p:nvPicPr>
                <p:blipFill>
                  <a:blip r:embed="rId2"/>
                  <a:stretch/>
                </p:blipFill>
                <p:spPr>
                  <a:xfrm>
                    <a:off x="250920" y="189000"/>
                    <a:ext cx="3529080" cy="3247920"/>
                  </a:xfrm>
                  <a:prstGeom prst="rect">
                    <a:avLst/>
                  </a:prstGeom>
                  <a:ln w="0">
                    <a:noFill/>
                  </a:ln>
                </p:spPr>
              </p:pic>
            </p:oleObj>
          </a:graphicData>
        </a:graphic>
      </p:graphicFrame>
      <p:graphicFrame>
        <p:nvGraphicFramePr>
          <p:cNvPr id="43" name="Object 6"/>
          <p:cNvGraphicFramePr/>
          <p:nvPr/>
        </p:nvGraphicFramePr>
        <p:xfrm>
          <a:off x="4932360" y="260280"/>
          <a:ext cx="3745080" cy="3063960"/>
        </p:xfrm>
        <a:graphic>
          <a:graphicData uri="http://schemas.openxmlformats.org/presentationml/2006/ole">
            <p:oleObj r:id="rId3" spid="">
              <p:embed/>
              <p:pic>
                <p:nvPicPr>
                  <p:cNvPr id="44" name="Object 6" descr=""/>
                  <p:cNvPicPr/>
                  <p:nvPr/>
                </p:nvPicPr>
                <p:blipFill>
                  <a:blip r:embed="rId4"/>
                  <a:stretch/>
                </p:blipFill>
                <p:spPr>
                  <a:xfrm>
                    <a:off x="4932360" y="260280"/>
                    <a:ext cx="3745080" cy="3063960"/>
                  </a:xfrm>
                  <a:prstGeom prst="rect">
                    <a:avLst/>
                  </a:prstGeom>
                  <a:ln w="0">
                    <a:noFill/>
                  </a:ln>
                </p:spPr>
              </p:pic>
            </p:oleObj>
          </a:graphicData>
        </a:graphic>
      </p:graphicFrame>
      <p:sp>
        <p:nvSpPr>
          <p:cNvPr id="45" name="Text Box 7"/>
          <p:cNvSpPr/>
          <p:nvPr/>
        </p:nvSpPr>
        <p:spPr>
          <a:xfrm>
            <a:off x="250920" y="3573360"/>
            <a:ext cx="8713800" cy="2864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rPr>
              <a:t>S1 Fig. Characterization of miR-142-3p expression in human breast cancer cell lines. </a:t>
            </a:r>
            <a:r>
              <a:rPr b="0" lang="de-DE" sz="1400" spc="-1" strike="noStrike">
                <a:solidFill>
                  <a:srgbClr val="000000"/>
                </a:solidFill>
                <a:latin typeface="Arial"/>
              </a:rPr>
              <a:t>a) Basal miR-142-3p expression levels relative to MDA-MB-468. microRNA was isolated from the indicated breast cancer cell lines, reverse transcribed and analyzed by TaqMan qPCR using ABI probes exactly as described in Götte et al. (2010). RNU6B served as a housekeeping RNA control. N=3, error bars = SD.  b) qPCR confirmation of successful upregulation of miR-142-3p after transfection with miR-142-3p and control miRNA precursors (see main manuscript and Götte et al. (2010) for details). microRNA was isolated 72h after transfection. N&gt;3, error bars = SEM.</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rPr>
              <a:t>Reference:</a:t>
            </a:r>
            <a:endParaRPr b="0" lang="en-US" sz="14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231f20"/>
                </a:solidFill>
                <a:latin typeface="AdvOT46dcae81"/>
              </a:rPr>
              <a:t>Götte M, Mohr C, Koo CY, Stock C, Vaske AK, Viola M, Ibrahim SA, Peddibhotla S, Teng YH, Low JY, Ebnet K, Kiesel L, Yip GW. </a:t>
            </a:r>
            <a:r>
              <a:rPr b="0" lang="en-US" sz="1400" spc="-1" strike="noStrike">
                <a:solidFill>
                  <a:srgbClr val="231f20"/>
                </a:solidFill>
                <a:latin typeface="AdvOT46dcae81"/>
              </a:rPr>
              <a:t>miR-145-dependent targeting of junctional adhesion molecule A and modulation of fascin expression are associated with reduced breast cancer cell motility and invasiveness. </a:t>
            </a:r>
            <a:r>
              <a:rPr b="0" i="1" lang="en-US" sz="1400" spc="-1" strike="noStrike">
                <a:solidFill>
                  <a:srgbClr val="231f20"/>
                </a:solidFill>
                <a:latin typeface="AdvOT46dcae81"/>
              </a:rPr>
              <a:t>Oncogene</a:t>
            </a:r>
            <a:r>
              <a:rPr b="0" lang="en-US" sz="1400" spc="-1" strike="noStrike">
                <a:solidFill>
                  <a:srgbClr val="231f20"/>
                </a:solidFill>
                <a:latin typeface="AdvOT46dcae81"/>
              </a:rPr>
              <a:t> 2010; </a:t>
            </a:r>
            <a:r>
              <a:rPr b="1" lang="de-DE" sz="1400" spc="-1" strike="noStrike">
                <a:solidFill>
                  <a:srgbClr val="231f20"/>
                </a:solidFill>
                <a:latin typeface="AdvOT46dcae81"/>
              </a:rPr>
              <a:t>29</a:t>
            </a:r>
            <a:r>
              <a:rPr b="0" lang="de-DE" sz="1400" spc="-1" strike="noStrike">
                <a:solidFill>
                  <a:srgbClr val="231f20"/>
                </a:solidFill>
                <a:latin typeface="AdvOT46dcae81"/>
              </a:rPr>
              <a:t>: 6569-6580.</a:t>
            </a:r>
            <a:endParaRPr b="0" lang="en-US" sz="1400" spc="-1" strike="noStrike">
              <a:solidFill>
                <a:srgbClr val="000000"/>
              </a:solidFill>
              <a:latin typeface="Arial"/>
            </a:endParaRPr>
          </a:p>
        </p:txBody>
      </p:sp>
      <p:sp>
        <p:nvSpPr>
          <p:cNvPr id="46" name="Text Box 8"/>
          <p:cNvSpPr/>
          <p:nvPr/>
        </p:nvSpPr>
        <p:spPr>
          <a:xfrm>
            <a:off x="180720" y="0"/>
            <a:ext cx="32256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2000" spc="-1" strike="noStrike">
                <a:solidFill>
                  <a:srgbClr val="000000"/>
                </a:solidFill>
                <a:latin typeface="Arial"/>
              </a:rPr>
              <a:t>a</a:t>
            </a:r>
            <a:endParaRPr b="0" lang="en-US" sz="2000" spc="-1" strike="noStrike">
              <a:solidFill>
                <a:srgbClr val="000000"/>
              </a:solidFill>
              <a:latin typeface="Arial"/>
            </a:endParaRPr>
          </a:p>
        </p:txBody>
      </p:sp>
      <p:sp>
        <p:nvSpPr>
          <p:cNvPr id="47" name="Text Box 9"/>
          <p:cNvSpPr/>
          <p:nvPr/>
        </p:nvSpPr>
        <p:spPr>
          <a:xfrm>
            <a:off x="4537080" y="3816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800" spc="-1" strike="noStrike">
                <a:solidFill>
                  <a:srgbClr val="000000"/>
                </a:solidFill>
                <a:latin typeface="Arial"/>
              </a:rPr>
              <a:t>b</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9-05T06:18:10Z</dcterms:created>
  <dc:creator>Martin Götte</dc:creator>
  <dc:description/>
  <dc:language>en-US</dc:language>
  <cp:lastModifiedBy>Prof. Dr. Martin Götte</cp:lastModifiedBy>
  <dcterms:modified xsi:type="dcterms:W3CDTF">2015-11-16T14:42:14Z</dcterms:modified>
  <cp:revision>13</cp:revision>
  <dc:subject/>
  <dc:title>Folie 1</dc:title>
</cp:coreProperties>
</file>